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3" autoAdjust="0"/>
    <p:restoredTop sz="94660"/>
  </p:normalViewPr>
  <p:slideViewPr>
    <p:cSldViewPr snapToGrid="0">
      <p:cViewPr varScale="1">
        <p:scale>
          <a:sx n="90" d="100"/>
          <a:sy n="90" d="100"/>
        </p:scale>
        <p:origin x="14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71204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4614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44787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6882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641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04766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657908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79056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57307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8215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084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D6B4B6-22EA-47FA-AE23-D76B85EAA8E1}" type="datetimeFigureOut">
              <a:rPr kumimoji="1" lang="ja-JP" altLang="en-US" smtClean="0"/>
              <a:t>2021/10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D3659F-4CFB-4E78-887A-0EC1042CE7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4815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"/>
          <p:cNvSpPr>
            <a:spLocks noChangeArrowheads="1"/>
          </p:cNvSpPr>
          <p:nvPr/>
        </p:nvSpPr>
        <p:spPr bwMode="auto">
          <a:xfrm>
            <a:off x="1044152" y="528821"/>
            <a:ext cx="5459104" cy="6406882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0" numCol="1" anchor="ctr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MLTDSKVKTAKAAEKAYRLSDSEGLFVHVMPTGKKFWRLRYRQQGKEQT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MLTDSKVKTAKAAEKAYRLSDSEGLFVHVMPTGKKFWRLRYRQQGKEQT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MLTDSKVKTAKAAEKAYRLSDSEGLFVHVMPTGKKFWRLRYRQHGKEQT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MLTDSKVKTAKAAEKAYRLSDSEGLFVHVMPTGKKFWRLRYRQQGKEQT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MLTDSKVKTAKAAEKAYRLSDSEGLFVHVMPTGKKFWRLRYRQQGKEQT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************************************: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TLGPYPSVGLREARMMRDNAKDLLRQGIDPNKAGKVAHLLAEPQQQDSFE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TLGPYPSVGLREARMMRDNAKDLLRQGIDPNKAGKVAHLLADPQQQDSFE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TLGPYPSVGLREARMMRDNAKDLLRQGIDPNKAGKVAHLLAEPQQQDSFE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TLGPYPSVGLREARMMRDNAKDLLRQGIDPNKAGKVAHLLAEPQQQDSFE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TLGPYPSVGLREARMMRDNAKDLLRQGIDPNKAGKVAHLLAEPQQQDSFE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**********************************:**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AVAREWYEQRKDLWRPRHAYDVIHSLERDVFHHIGHLAPGQITPRVVLHI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AVAREWYGQRKDLWRPRHAYDVIHSLERDVFPHIGHLPPGQITPRVVLHI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AVAREWYEQRKDLWRPRHAYDVIHSLERDVFPHIGHLPPGQITPRVVLHI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AVAREWYEQRKDLWRPRHAYDVIHSLERDVFPHIGHLPPGQITPRVVLHI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AVAREWYEQRKDLWRPRHAYDVIHSLERDVFPHIGHLAPGQITPRVVLHI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 *********************** *****.******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LKGIEERGAVETAHRIRQRMSDVFVHAIATERADTDPAGIVKPALRPVIR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LKGIEERGAVETAHRIRQRMSDVFVHAIATERADTDPAGIVKPALRPVIR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LKGIEERGAVETAHRIRQRMSDVFVHAIATERADTDPAGIVKPALRPVIR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LKGIEERGAVETAHRIRQRMSDVFVHAIATERADTDPAGIVKPALRPVIR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LKGIEERGAVETAHRIRQRMSDVFVHAIATERADTDPAGIVKPALRPVIR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*************************************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NRQPAITDLEQAREMIARVESCVAHPVTLLAFRLLYLTAVRPGEVRAAMW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NRQPAITDLEQAREMIARVESCVAHPVTLLAFRLLYLTAVRPGEVRAAMW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NRQPAITDLEQAREMIARVESCVAHPVTLLAFRLLYLTAVRPGEVRAAMW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NRQPAITDLEQAREMIARVESCVAHPVTLLAFRLLYLTAVRPGEVRAAMW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NRQPAITDLEQAREMIARVESCVAHPVTLLAFRLLYLTAVRPGEVRAAMW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*************************************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DE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FHGLD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SQEPVWIIPAERMKMSREHIVPLSPQAVDVVQAVRPFSSRWPH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DEFHDLDSQDPVWIIPAERMKMSREHIVPLSPQAVNVVQAVRPFSSRWPH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DEFHDLDSQDPVWIIPAERMKMSREHIVPLSPQAVNVVQAVRPFSSRWPH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DEFHGLDSQEPVWIIPAERMKMSREHIVPLSPQAVDVVQAVRPFSSRWPH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DEFHDLDSQEPVWVIPAERMKMSREHIVPLSPQAVDVVQAVRPFSSRWPH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.****:***:*********************:********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LFPNTRRPKLPMSENAIGYLINRAGYHGRHVPHGFRSTFSSNMNERFPLD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LFPNTRRPKLPMSENAIGYLINRAGYHGRHVPHGFRSTFSSNMNERFPLD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LFPNTRRPKLPMSENAIGYLINRAGYHGRHVPHGFRSTFSSNMNERFPLD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LFPNTRRPKLPMSENAIGYLINRAGYHGRHVPHGFRSTFSSNMNERFPLD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lang="en-US" altLang="ja-JP" sz="900" i="1" dirty="0" smtClean="0">
                <a:solidFill>
                  <a:srgbClr val="000000"/>
                </a:solidFill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LFPNTRRPKLPMSENAIGYLINRAGYHGRHVPHGFRSTFSSNMNERFPLD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*******************************************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HDVIELMLAHASKDKVAAAYNRALYLDRRRELATIWSRLILEGQKPVDD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HDVIELMLAHASKDKVAAAYNRALYLDRRRELATIWSGLILEGQKPVDD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HDVIELMLAHASKDKVAAAYNRALYLDRRRELATIWSGLILALQLHFVS-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HDVIELMLAHASKDKVAAAYNRALYIDRRRELATIWANLILNG-------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HDVIELMLAHAPKDKVAAAYNRALYIDRRRELSTIWANLILDGQNSLGKL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                               ***********.*************:******:***: ***         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rgbClr val="000000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  <a:cs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0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109446      VSAQRKPAGIEA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262         VSAQRKPAGIEA</a:t>
            </a:r>
            <a:endParaRPr kumimoji="0" lang="en-US" altLang="ja-JP" sz="900" b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b3             ------------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L="0" marR="0" lvl="0" indent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NBRC3188        ------------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  <a:p>
            <a:pPr marR="0" lvl="0" algn="l" defTabSz="914400" rtl="0" eaLnBrk="0" fontAlgn="base" latinLnBrk="0" hangingPunct="0">
              <a:lnSpc>
                <a:spcPts val="800"/>
              </a:lnSpc>
              <a:spcBef>
                <a:spcPct val="0"/>
              </a:spcBef>
              <a:spcAft>
                <a:spcPct val="0"/>
              </a:spcAft>
              <a:buClrTx/>
              <a:buSzTx/>
              <a:tabLst>
                <a:tab pos="581025" algn="l"/>
                <a:tab pos="1163638" algn="l"/>
                <a:tab pos="1744663" algn="l"/>
                <a:tab pos="2327275" algn="l"/>
                <a:tab pos="2908300" algn="l"/>
                <a:tab pos="3489325" algn="l"/>
                <a:tab pos="4071938" algn="l"/>
                <a:tab pos="4652963" algn="l"/>
                <a:tab pos="5235575" algn="l"/>
                <a:tab pos="5816600" algn="l"/>
                <a:tab pos="6397625" algn="l"/>
                <a:tab pos="6980238" algn="l"/>
                <a:tab pos="7561263" algn="l"/>
                <a:tab pos="8143875" algn="l"/>
                <a:tab pos="8724900" algn="l"/>
                <a:tab pos="9305925" algn="l"/>
              </a:tabLst>
            </a:pPr>
            <a:r>
              <a:rPr kumimoji="0" lang="en-US" altLang="ja-JP" sz="900" b="0" i="1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A. </a:t>
            </a:r>
            <a:r>
              <a:rPr kumimoji="0" lang="en-US" altLang="ja-JP" sz="900" b="0" i="1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pasteurianus</a:t>
            </a:r>
            <a:r>
              <a:rPr kumimoji="0" lang="en-US" altLang="ja-JP" sz="900" b="0" i="1" u="none" strike="noStrike" cap="none" normalizeH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 </a:t>
            </a:r>
            <a:r>
              <a:rPr kumimoji="0" lang="en-US" altLang="ja-JP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LMG1591         ISIKR-------</a:t>
            </a:r>
          </a:p>
          <a:p>
            <a:pPr lvl="0" defTabSz="914400">
              <a:lnSpc>
                <a:spcPts val="800"/>
              </a:lnSpc>
            </a:pPr>
            <a:r>
              <a:rPr lang="en-US" altLang="ja-JP" sz="900" dirty="0" smtClean="0">
                <a:solidFill>
                  <a:srgbClr val="000000"/>
                </a:solidFill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                                </a:t>
            </a:r>
            <a:r>
              <a:rPr lang="en-US" altLang="ja-JP" sz="900" dirty="0" smtClean="0">
                <a:solidFill>
                  <a:srgbClr val="000000"/>
                </a:solidFill>
                <a:latin typeface="ＭＳ ゴシック" panose="020B0609070205080204" pitchFamily="49" charset="-128"/>
                <a:ea typeface="ＭＳ ゴシック" panose="020B0609070205080204" pitchFamily="49" charset="-128"/>
                <a:cs typeface="ＭＳ ゴシック" panose="020B0609070205080204" pitchFamily="49" charset="-128"/>
              </a:rPr>
              <a:t>.*  *</a:t>
            </a:r>
            <a:r>
              <a:rPr lang="en-US" altLang="ja-JP" sz="900" dirty="0" smtClean="0">
                <a:solidFill>
                  <a:srgbClr val="000000"/>
                </a:solidFill>
                <a:latin typeface="ＭＳ ゴシック" panose="020B0609070205080204" pitchFamily="49" charset="-128"/>
                <a:ea typeface="ＭＳ ゴシック" panose="020B0609070205080204" pitchFamily="49" charset="-128"/>
              </a:rPr>
              <a:t> </a:t>
            </a:r>
            <a:endParaRPr kumimoji="0" lang="en-US" altLang="ja-JP" sz="9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ＭＳ ゴシック" panose="020B0609070205080204" pitchFamily="49" charset="-128"/>
              <a:ea typeface="ＭＳ ゴシック" panose="020B0609070205080204" pitchFamily="49" charset="-128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163774" y="7533564"/>
            <a:ext cx="6513251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3 Multiple alignment of integrases</a:t>
            </a:r>
            <a:r>
              <a:rPr kumimoji="1" lang="ja-JP" altLang="en-US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ncoded in phiAP1-like elements.</a:t>
            </a:r>
          </a:p>
          <a:p>
            <a:pPr algn="just"/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mino acid sequences of integrases derived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from 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the phiAP1-like 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elements of </a:t>
            </a:r>
            <a:r>
              <a:rPr kumimoji="1" lang="en-US" altLang="ja-JP" sz="1100" i="1" dirty="0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  <a:r>
              <a:rPr kumimoji="1" lang="en-US" altLang="ja-JP" sz="11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steurianus</a:t>
            </a:r>
            <a:r>
              <a:rPr kumimoji="1"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were compared with CLUSTAL W.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sterisks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colons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, and periods indicate the completely, highly, and semi-conserved </a:t>
            </a:r>
            <a:r>
              <a:rPr lang="en-US" altLang="ja-JP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amino acid residues,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respectively.   </a:t>
            </a:r>
            <a:endParaRPr kumimoji="1" lang="ja-JP" alt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549284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2</TotalTime>
  <Words>303</Words>
  <Application>Microsoft Office PowerPoint</Application>
  <PresentationFormat>画面に合わせる (4:3)</PresentationFormat>
  <Paragraphs>6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ゴシック</vt:lpstr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noshima</dc:creator>
  <cp:lastModifiedBy>enoshima</cp:lastModifiedBy>
  <cp:revision>44</cp:revision>
  <dcterms:created xsi:type="dcterms:W3CDTF">2019-01-17T04:50:18Z</dcterms:created>
  <dcterms:modified xsi:type="dcterms:W3CDTF">2021-10-12T06:29:58Z</dcterms:modified>
</cp:coreProperties>
</file>